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8" r:id="rId2"/>
    <p:sldId id="34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47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01F4E0-AD0E-45EE-A770-B951D6701BC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6D7CB1-39A9-4A4F-9849-02455F3077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0630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260A07-6951-4F27-A1FA-2E594FB0B4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84F01CC-2786-474A-B432-285D33AE47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1139B4-3A5F-42A5-ACB8-3E41DA678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AA10A1-1A60-4C5C-B84C-948915FD1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6201EC-CB83-4B16-91F0-F5E52EC3C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6907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63A105-49C3-4995-9499-0A8997D016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0898095-0BF6-4246-91A9-F9BC5262BE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BE17A8-2E98-439D-8020-248063C4A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1C2826-5105-49CB-9356-8A70547D8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FAD31C-049A-4864-A883-4936352D6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7721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E46815E-8DF0-4013-8977-9CCB184206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F3FFE84-0DD0-4250-8295-162B46CE54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AB41F9-A778-4083-8E3F-15368BA1B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834B29-3EB7-4257-8752-55AE7A09F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F20927-58D0-401E-B184-8ED6079A7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379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A553B2-4462-47E8-812E-5A180E6D0B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D172ED-F29A-438C-AEE9-A963282BF4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D4E4B3-DE17-4916-A7FF-F79CB841F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BEDFFF-1964-4588-8203-788BE2D3A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0040CF-4019-481D-87BA-A0E9777C9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629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438A63-49F0-47C0-B79E-38EDBAC04D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5366A74-B0B7-409B-B6D1-210692B18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A5D1AC-96FA-4824-92AD-1A4FC9CF6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F07BDD-E975-41F4-BC5F-1F09B63C0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0D7B94-7F0C-4FF9-B580-E59CE9A6E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8819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BD51B6-4B99-4156-887D-83B3E4EC27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CDF7DA-0EC5-4003-9575-240AEB8521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59187F0-7E7B-4547-AE0E-66B771AE9B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A41030-BFFC-4D15-98D0-0F63F2930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6C3A4B-6F2A-4E3E-BF79-9AB301E7E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318CCE-684B-42FD-9706-F0CA9089B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402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9B1A70-5FF7-46AC-A6F1-BD5F2E6ABA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BDD78B3-81AF-4B66-91D5-1393FCC4E4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73559F-2A7B-4062-9466-3BED9743AE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10285FE-FFA3-4722-86A4-5B57874B0A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4B3D25C-2FBE-4F3D-9646-AF95DB3D8B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BC427F1-A54B-4D59-ACA2-74D17E09A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5BD237C-452E-438D-8CE7-89ACCB78E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4087499-DBAA-44F1-8BD0-B73DD29C8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2397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E605B8-8D69-4A11-94D0-61A679955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7D7D337-3DC4-4B89-B944-01E572C00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C303AFB-022E-4DC3-A311-523E05549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ECCBE67-D5D3-42C6-A31E-1957402A2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4218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818BA4C-C27A-46B5-954B-B356AB000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C10B6E9-BD60-4472-944D-51C28097C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2BF52AA-B74C-4B1A-94B3-2C002AEBA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809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8C4BD8-D43E-4C04-8E82-D754008BE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5CE9CA-3981-48A1-89F3-DC26B2FAF3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6A72DB-555F-4EB1-AD6B-85A9FA9CAA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93DD06-080C-4C85-BE61-83807A511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15EA03B-1AFA-4624-9BC7-BA0D4BDDE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54418CA-3EFC-4882-8823-98D469CAA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1404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E6100E-EE35-4927-AB6D-6F54780BA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3E737F0-DC8D-4B74-98ED-352FE1B1F1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0E6D665-32AE-43C2-8B2E-A464D44350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96BED1-B8DC-4D7F-896B-75B9C76B4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AAEAC68-84D5-45DE-B203-26FBAA8F7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502C239-766A-465A-926F-BFEF4A4A4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085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2CB37E7-31E7-4FB2-8DCB-4C39492695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5C50D6-9E44-40D7-B36A-905CCE3A5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D4E537-A875-480B-8DA7-F528B3410B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D2CD9-D38A-46E8-8BFD-A5B92318F0A5}" type="datetimeFigureOut">
              <a:rPr lang="zh-CN" altLang="en-US" smtClean="0"/>
              <a:t>2020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228EBD-D7F6-48E3-886D-47D30DB3CB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B1FBB2-FA76-4124-B2BA-52C7624A49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72B55-14D5-4AFE-86EE-9C2FFEAFF0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4743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A0228100-62D6-4DFF-9B7E-8A54E440CF0F}"/>
              </a:ext>
            </a:extLst>
          </p:cNvPr>
          <p:cNvSpPr txBox="1"/>
          <p:nvPr/>
        </p:nvSpPr>
        <p:spPr>
          <a:xfrm>
            <a:off x="2676193" y="1447800"/>
            <a:ext cx="6052939" cy="339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nex 1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aveform used in PAD for HPAEC detecting</a:t>
            </a:r>
            <a:endParaRPr lang="zh-CN" altLang="zh-CN" sz="12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8CFE5503-1C71-4734-8853-C2B55B40B4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432298"/>
              </p:ext>
            </p:extLst>
          </p:nvPr>
        </p:nvGraphicFramePr>
        <p:xfrm>
          <a:off x="2676193" y="1899409"/>
          <a:ext cx="5722738" cy="185978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07349">
                  <a:extLst>
                    <a:ext uri="{9D8B030D-6E8A-4147-A177-3AD203B41FA5}">
                      <a16:colId xmlns:a16="http://schemas.microsoft.com/office/drawing/2014/main" val="1244759894"/>
                    </a:ext>
                  </a:extLst>
                </a:gridCol>
                <a:gridCol w="1907349">
                  <a:extLst>
                    <a:ext uri="{9D8B030D-6E8A-4147-A177-3AD203B41FA5}">
                      <a16:colId xmlns:a16="http://schemas.microsoft.com/office/drawing/2014/main" val="3557876649"/>
                    </a:ext>
                  </a:extLst>
                </a:gridCol>
                <a:gridCol w="1908040">
                  <a:extLst>
                    <a:ext uri="{9D8B030D-6E8A-4147-A177-3AD203B41FA5}">
                      <a16:colId xmlns:a16="http://schemas.microsoft.com/office/drawing/2014/main" val="1307971296"/>
                    </a:ext>
                  </a:extLst>
                </a:gridCol>
              </a:tblGrid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veform Time/s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tential/v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p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726425"/>
                  </a:ext>
                </a:extLst>
              </a:tr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kern="10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6827926"/>
                  </a:ext>
                </a:extLst>
              </a:tr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zh-CN" sz="1200" kern="10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gin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6537030"/>
                  </a:ext>
                </a:extLst>
              </a:tr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</a:t>
                      </a:r>
                      <a:endParaRPr lang="zh-CN" sz="1200" kern="10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6856582"/>
                  </a:ext>
                </a:extLst>
              </a:tr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r>
                        <a:rPr lang="en-US" altLang="zh-CN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</a:t>
                      </a: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2.0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4403825"/>
                  </a:ext>
                </a:extLst>
              </a:tr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  <a:endParaRPr lang="zh-CN" sz="1200" kern="10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zh-CN" sz="1200" kern="10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6662921"/>
                  </a:ext>
                </a:extLst>
              </a:tr>
              <a:tr h="26568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  <a:r>
                        <a:rPr lang="en-US" altLang="zh-CN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</a:t>
                      </a: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0.1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kern="1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54950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6844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3AAAE748-3095-4740-A5F0-9E760CBBEF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4620388"/>
              </p:ext>
            </p:extLst>
          </p:nvPr>
        </p:nvGraphicFramePr>
        <p:xfrm>
          <a:off x="1945930" y="559556"/>
          <a:ext cx="9181386" cy="5174183"/>
        </p:xfrm>
        <a:graphic>
          <a:graphicData uri="http://schemas.openxmlformats.org/drawingml/2006/table">
            <a:tbl>
              <a:tblPr firstRow="1" firstCol="1" bandRow="1"/>
              <a:tblGrid>
                <a:gridCol w="1156342">
                  <a:extLst>
                    <a:ext uri="{9D8B030D-6E8A-4147-A177-3AD203B41FA5}">
                      <a16:colId xmlns:a16="http://schemas.microsoft.com/office/drawing/2014/main" val="664476751"/>
                    </a:ext>
                  </a:extLst>
                </a:gridCol>
                <a:gridCol w="447393">
                  <a:extLst>
                    <a:ext uri="{9D8B030D-6E8A-4147-A177-3AD203B41FA5}">
                      <a16:colId xmlns:a16="http://schemas.microsoft.com/office/drawing/2014/main" val="1550258469"/>
                    </a:ext>
                  </a:extLst>
                </a:gridCol>
                <a:gridCol w="461161">
                  <a:extLst>
                    <a:ext uri="{9D8B030D-6E8A-4147-A177-3AD203B41FA5}">
                      <a16:colId xmlns:a16="http://schemas.microsoft.com/office/drawing/2014/main" val="3615459189"/>
                    </a:ext>
                  </a:extLst>
                </a:gridCol>
                <a:gridCol w="509341">
                  <a:extLst>
                    <a:ext uri="{9D8B030D-6E8A-4147-A177-3AD203B41FA5}">
                      <a16:colId xmlns:a16="http://schemas.microsoft.com/office/drawing/2014/main" val="2474335824"/>
                    </a:ext>
                  </a:extLst>
                </a:gridCol>
                <a:gridCol w="2564231">
                  <a:extLst>
                    <a:ext uri="{9D8B030D-6E8A-4147-A177-3AD203B41FA5}">
                      <a16:colId xmlns:a16="http://schemas.microsoft.com/office/drawing/2014/main" val="3052379964"/>
                    </a:ext>
                  </a:extLst>
                </a:gridCol>
                <a:gridCol w="368308">
                  <a:extLst>
                    <a:ext uri="{9D8B030D-6E8A-4147-A177-3AD203B41FA5}">
                      <a16:colId xmlns:a16="http://schemas.microsoft.com/office/drawing/2014/main" val="4067761356"/>
                    </a:ext>
                  </a:extLst>
                </a:gridCol>
                <a:gridCol w="306923">
                  <a:extLst>
                    <a:ext uri="{9D8B030D-6E8A-4147-A177-3AD203B41FA5}">
                      <a16:colId xmlns:a16="http://schemas.microsoft.com/office/drawing/2014/main" val="2555590083"/>
                    </a:ext>
                  </a:extLst>
                </a:gridCol>
                <a:gridCol w="510187">
                  <a:extLst>
                    <a:ext uri="{9D8B030D-6E8A-4147-A177-3AD203B41FA5}">
                      <a16:colId xmlns:a16="http://schemas.microsoft.com/office/drawing/2014/main" val="1871616186"/>
                    </a:ext>
                  </a:extLst>
                </a:gridCol>
                <a:gridCol w="227171">
                  <a:extLst>
                    <a:ext uri="{9D8B030D-6E8A-4147-A177-3AD203B41FA5}">
                      <a16:colId xmlns:a16="http://schemas.microsoft.com/office/drawing/2014/main" val="1099004246"/>
                    </a:ext>
                  </a:extLst>
                </a:gridCol>
                <a:gridCol w="107047">
                  <a:extLst>
                    <a:ext uri="{9D8B030D-6E8A-4147-A177-3AD203B41FA5}">
                      <a16:colId xmlns:a16="http://schemas.microsoft.com/office/drawing/2014/main" val="1873734344"/>
                    </a:ext>
                  </a:extLst>
                </a:gridCol>
                <a:gridCol w="624632">
                  <a:extLst>
                    <a:ext uri="{9D8B030D-6E8A-4147-A177-3AD203B41FA5}">
                      <a16:colId xmlns:a16="http://schemas.microsoft.com/office/drawing/2014/main" val="667940799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264819183"/>
                    </a:ext>
                  </a:extLst>
                </a:gridCol>
                <a:gridCol w="309306">
                  <a:extLst>
                    <a:ext uri="{9D8B030D-6E8A-4147-A177-3AD203B41FA5}">
                      <a16:colId xmlns:a16="http://schemas.microsoft.com/office/drawing/2014/main" val="1881022925"/>
                    </a:ext>
                  </a:extLst>
                </a:gridCol>
                <a:gridCol w="90744">
                  <a:extLst>
                    <a:ext uri="{9D8B030D-6E8A-4147-A177-3AD203B41FA5}">
                      <a16:colId xmlns:a16="http://schemas.microsoft.com/office/drawing/2014/main" val="1795563793"/>
                    </a:ext>
                  </a:extLst>
                </a:gridCol>
                <a:gridCol w="342886">
                  <a:extLst>
                    <a:ext uri="{9D8B030D-6E8A-4147-A177-3AD203B41FA5}">
                      <a16:colId xmlns:a16="http://schemas.microsoft.com/office/drawing/2014/main" val="6851744"/>
                    </a:ext>
                  </a:extLst>
                </a:gridCol>
                <a:gridCol w="546114">
                  <a:extLst>
                    <a:ext uri="{9D8B030D-6E8A-4147-A177-3AD203B41FA5}">
                      <a16:colId xmlns:a16="http://schemas.microsoft.com/office/drawing/2014/main" val="3370091497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738687941"/>
                    </a:ext>
                  </a:extLst>
                </a:gridCol>
              </a:tblGrid>
              <a:tr h="114300">
                <a:tc>
                  <a:txBody>
                    <a:bodyPr/>
                    <a:lstStyle/>
                    <a:p>
                      <a:endParaRPr lang="zh-CN" sz="8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libration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sz="8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ross validation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xternal validation</a:t>
                      </a:r>
                      <a:endParaRPr lang="zh-CN" sz="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304487"/>
                  </a:ext>
                </a:extLst>
              </a:tr>
              <a:tr h="55972">
                <a:tc>
                  <a:txBody>
                    <a:bodyPr/>
                    <a:lstStyle/>
                    <a:p>
                      <a:endParaRPr lang="zh-CN" sz="8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nk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M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pectrum range (cm</a:t>
                      </a:r>
                      <a:r>
                        <a:rPr lang="en-US" sz="800" kern="100" baseline="300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ean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D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C</a:t>
                      </a:r>
                      <a:endParaRPr lang="zh-CN" sz="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800" i="1" kern="100" baseline="300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800" i="1" kern="100" baseline="300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sz="8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CV</a:t>
                      </a:r>
                      <a:endParaRPr lang="zh-CN" sz="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800" i="1" kern="100" baseline="300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800" i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v</a:t>
                      </a:r>
                      <a:endParaRPr lang="zh-CN" sz="800" i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PD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  <a:endParaRPr lang="zh-CN" sz="8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P</a:t>
                      </a:r>
                      <a:endParaRPr lang="zh-CN" sz="8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i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800" i="1" kern="100" baseline="300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800" i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v</a:t>
                      </a:r>
                      <a:endParaRPr lang="zh-CN" sz="800" i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534460"/>
                  </a:ext>
                </a:extLst>
              </a:tr>
              <a:tr h="13372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ry weight (Offline)</a:t>
                      </a:r>
                      <a:endParaRPr lang="zh-CN" sz="800" b="1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233919"/>
                  </a:ext>
                </a:extLst>
              </a:tr>
              <a:tr h="13372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gars </a:t>
                      </a:r>
                      <a:r>
                        <a:rPr lang="en-US" altLang="zh-CN" sz="8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% dry weigh)</a:t>
                      </a:r>
                      <a:endParaRPr lang="zh-CN" altLang="en-US" sz="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1312184"/>
                  </a:ext>
                </a:extLst>
              </a:tr>
              <a:tr h="15239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Glucose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 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 7251.4,8825.1~ 96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8241342"/>
                  </a:ext>
                </a:extLst>
              </a:tr>
              <a:tr h="169558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Fructose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10398.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171268"/>
                  </a:ext>
                </a:extLst>
              </a:tr>
              <a:tr h="12870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Reducing sugar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7251.4,8825.1~9612,10398.8~11185.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6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6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092830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Sucrose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 7251.4,8038.3~ 10398.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9.2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.1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3042882"/>
                  </a:ext>
                </a:extLst>
              </a:tr>
              <a:tr h="15883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Total sugar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90.8~ 5677.7,6464.5~ 7251.4,8038.3~ 10398.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1.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.2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17907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sidues</a:t>
                      </a:r>
                      <a:endParaRPr lang="zh-CN" altLang="en-US" sz="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2.8~5276.6,5793.4~7344,7860.8~8377.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.0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.1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065858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8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tio</a:t>
                      </a:r>
                      <a:endParaRPr lang="zh-CN" sz="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654815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g</a:t>
                      </a: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/Res</a:t>
                      </a:r>
                      <a:endParaRPr lang="zh-CN" altLang="en-US" sz="800" kern="1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96~119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1172924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c</a:t>
                      </a: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/Total</a:t>
                      </a:r>
                      <a:endParaRPr lang="zh-CN" altLang="en-US" sz="800" kern="1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2.8~7860.8,8886.8~9403.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2037676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ru</a:t>
                      </a: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c</a:t>
                      </a:r>
                      <a:endParaRPr lang="zh-CN" altLang="en-US" sz="800" kern="1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759.7~5276.6,5793.4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267333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8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ry weight(Online)</a:t>
                      </a:r>
                      <a:endParaRPr lang="zh-CN" sz="800" b="1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7678209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gars</a:t>
                      </a:r>
                      <a:endParaRPr lang="zh-CN" altLang="en-US" sz="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9205500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Glucose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0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90.8~11185.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4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8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1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0491263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Fructose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8038.3,8825.1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8267124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Reducing sugar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2.8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51457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Sucrose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677.7~10398.8,11185.7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9.5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8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8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1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5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7071219"/>
                  </a:ext>
                </a:extLst>
              </a:tr>
              <a:tr h="15382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Total sugar 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6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677.7~7251.4,8038.3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2.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8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4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9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6633500"/>
                  </a:ext>
                </a:extLst>
              </a:tr>
              <a:tr h="15984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sidues</a:t>
                      </a:r>
                      <a:endParaRPr lang="zh-CN" altLang="en-US" sz="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752~6834.8,7853.1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7.4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5</a:t>
                      </a: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0127113"/>
                  </a:ext>
                </a:extLst>
              </a:tr>
              <a:tr h="11242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8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tio</a:t>
                      </a:r>
                      <a:endParaRPr lang="zh-CN" altLang="zh-CN" sz="800" b="1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753808"/>
                  </a:ext>
                </a:extLst>
              </a:tr>
              <a:tr h="120015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g</a:t>
                      </a: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/Res</a:t>
                      </a:r>
                      <a:endParaRPr lang="zh-CN" altLang="en-US" sz="800" kern="1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6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6518539"/>
                  </a:ext>
                </a:extLst>
              </a:tr>
              <a:tr h="160895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c</a:t>
                      </a: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/Total</a:t>
                      </a:r>
                      <a:endParaRPr lang="zh-CN" altLang="en-US" sz="800" kern="1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752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5023121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ru</a:t>
                      </a:r>
                      <a:r>
                        <a:rPr lang="en-US" altLang="zh-CN" sz="800" kern="1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altLang="zh-CN" sz="800" kern="100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c</a:t>
                      </a:r>
                      <a:endParaRPr lang="zh-CN" altLang="en-US" sz="800" kern="1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2.8~7344,7853.1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9100381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resh weight(Online)</a:t>
                      </a:r>
                      <a:endParaRPr lang="zh-CN" altLang="zh-CN" sz="800" b="1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en-US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633251"/>
                  </a:ext>
                </a:extLst>
              </a:tr>
              <a:tr h="14952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oisture</a:t>
                      </a:r>
                      <a:endParaRPr lang="zh-CN" sz="800" b="1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 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3.2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3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2590649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gars</a:t>
                      </a:r>
                      <a:endParaRPr lang="zh-CN" altLang="en-US" sz="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en-US" altLang="zh-CN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4305164"/>
                  </a:ext>
                </a:extLst>
              </a:tr>
              <a:tr h="14222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Glucose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5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6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4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7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8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8830623"/>
                  </a:ext>
                </a:extLst>
              </a:tr>
              <a:tr h="13491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Fructose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9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7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3791781"/>
                  </a:ext>
                </a:extLst>
              </a:tr>
              <a:tr h="13491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8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Reducing sugar</a:t>
                      </a:r>
                      <a:endParaRPr lang="zh-CN" altLang="en-US" sz="8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2.8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239383"/>
                  </a:ext>
                </a:extLst>
              </a:tr>
              <a:tr h="13491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Sucrose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MSC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4~11972.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.32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4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7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89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0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3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2896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   Total sugar </a:t>
                      </a:r>
                      <a:endParaRPr lang="zh-CN" sz="800" b="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6</a:t>
                      </a:r>
                      <a:endParaRPr lang="zh-CN" altLang="en-US" sz="8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276.6~ 7344,7853.1~ 8377.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.0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96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1900131"/>
                  </a:ext>
                </a:extLst>
              </a:tr>
              <a:tr h="215359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b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sidues</a:t>
                      </a:r>
                      <a:endParaRPr lang="zh-CN" altLang="en-US" sz="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2822" marR="2282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D+SNV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276.6~9411.4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.60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7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5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2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3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altLang="zh-CN" sz="8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8</a:t>
                      </a:r>
                      <a:endParaRPr lang="zh-CN" altLang="en-US" sz="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9961" marR="199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6988988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4EC28678-C5F1-43BF-AFAA-774D95BFD585}"/>
              </a:ext>
            </a:extLst>
          </p:cNvPr>
          <p:cNvSpPr txBox="1"/>
          <p:nvPr/>
        </p:nvSpPr>
        <p:spPr>
          <a:xfrm>
            <a:off x="1883444" y="5792250"/>
            <a:ext cx="9243872" cy="6510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050"/>
              </a:lnSpc>
            </a:pPr>
            <a:r>
              <a:rPr lang="en-US" altLang="zh-CN" sz="9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, sample number; SCM, scatter correction methods; SD, standard deviation of reference value; RMSEC, root mean square error of calibration; </a:t>
            </a:r>
            <a:r>
              <a:rPr lang="en-US" altLang="zh-CN" sz="9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900" i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9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determination coefficient; RMSECV, root mean square error of cross validation; </a:t>
            </a:r>
            <a:r>
              <a:rPr lang="en-US" altLang="zh-CN" sz="9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900" i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9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</a:t>
            </a:r>
            <a:r>
              <a:rPr lang="en-US" altLang="zh-CN" sz="9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determination coefficient of cross validation</a:t>
            </a:r>
            <a:r>
              <a:rPr lang="en-US" altLang="zh-CN" sz="900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altLang="zh-CN" sz="9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MSEP, root mean square error of external validation; </a:t>
            </a:r>
            <a:r>
              <a:rPr lang="en-US" altLang="zh-CN" sz="9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900" i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9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v</a:t>
            </a:r>
            <a:r>
              <a:rPr lang="en-US" altLang="zh-CN" sz="9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determination coefficient of external validation; RPD, ratio performance deviation; SNV, standard normal variate; MSC, standard multiple scatter; FD, first derivative; FD+SNV, a combination of  FD and SNV; FD+MSC, a combination of  FD and MSC.</a:t>
            </a:r>
            <a:endParaRPr lang="zh-CN" altLang="zh-CN" sz="9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49C6040C-3DF9-4C16-9406-7412EC2773CF}"/>
              </a:ext>
            </a:extLst>
          </p:cNvPr>
          <p:cNvSpPr/>
          <p:nvPr/>
        </p:nvSpPr>
        <p:spPr>
          <a:xfrm>
            <a:off x="1883444" y="241405"/>
            <a:ext cx="7430611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nex 2 </a:t>
            </a:r>
            <a:r>
              <a:rPr lang="en-US" altLang="zh-CN" sz="900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atistics for equations generated for prediction of biomass components in sugarcane stalks.</a:t>
            </a:r>
          </a:p>
        </p:txBody>
      </p:sp>
    </p:spTree>
    <p:extLst>
      <p:ext uri="{BB962C8B-B14F-4D97-AF65-F5344CB8AC3E}">
        <p14:creationId xmlns:p14="http://schemas.microsoft.com/office/powerpoint/2010/main" val="1053391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</TotalTime>
  <Words>693</Words>
  <Application>Microsoft Office PowerPoint</Application>
  <PresentationFormat>宽屏</PresentationFormat>
  <Paragraphs>45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ang JF</dc:creator>
  <cp:lastModifiedBy>Huang JF</cp:lastModifiedBy>
  <cp:revision>16</cp:revision>
  <dcterms:created xsi:type="dcterms:W3CDTF">2020-08-24T07:15:28Z</dcterms:created>
  <dcterms:modified xsi:type="dcterms:W3CDTF">2020-09-13T02:55:48Z</dcterms:modified>
</cp:coreProperties>
</file>